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3EEB6C-6F45-4B30-B5CB-1570CB084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2C6213A-B8AD-FC24-AC25-F2F08DF4D2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26ABEE-E381-0EBC-1BF0-5FC455792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FB30E7-FBF9-60C8-43B5-99116E50F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58B244-B514-BB3C-26F3-1D0F7BFD2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453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341467-BD34-36FF-B068-2E126639C6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29924DF-C06B-41FA-1E7F-CA659C1989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5BFD7B-D042-212C-2827-F0F46C9FD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F8C458-09A9-7AD7-F838-83A8087BB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0805AA-9681-BFE7-C2AD-99AB58222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625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14295CC-7688-087C-9E7D-883F8921B1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D9F9206-6BA9-369F-FB0E-2D8DCF92B2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92ED99-B506-C968-89F0-F94B210A4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8FEFA3-3661-2147-9DBE-4E1FBE615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085F56-E6AC-5B26-933A-407B58F52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34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4850F0-B788-4961-3F4A-1DA9E6DF4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EE4C05-BD4D-0DF5-FA1A-1336B54B5E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FBDDD3-C33F-4D0F-641B-8E99758CA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BEA000-723C-B182-F360-34AAB6CA2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0F9D03-1A21-EF00-781A-4701200E7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924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7B1C9B-CBC8-5850-C82D-90E715509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1C71BB-787D-02B7-F385-78B0C89FAD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A29C47-E854-71E5-215C-0811D2E30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9D1E9B-91D2-A631-308F-F04A33CA6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8FB6F0-99CD-3A72-20B1-99250E800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122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6716D0-2929-A16E-9D9D-E0A2033915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B68D666-DE9B-F32A-E3CD-0AD0AEEC6A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69BD7D7-913A-618A-6EB2-ED0EE8202F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FFA8C4-852D-4B1F-7DD4-DBF97B389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33C99BD-4D74-8FFD-65B6-DBFE4CCFC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B933A4-BED9-1963-BC5F-BAA7428C1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80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56692D-17D3-2EB3-860C-D3E887168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042958D-6E62-2D35-C642-0DEB46F287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256C1AF-EBFB-7DF3-282F-B578D759C4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A6524C8-F507-6B73-F279-D1B82A23FE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F77339D-360F-F1FF-0616-C7159769D9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3A6BD36-3010-6BFD-EE76-91FD28B05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DC835D9-10AE-006D-5B8A-F9F0EB9D6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83A56B-60D9-E15F-1E1B-113D80C19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5653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38E389-DDC0-017A-5104-241FFECD56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8287058-AE79-D172-B60F-61E80E3F7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24E555E-8C79-B5B3-2016-91D591D93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E3AE135-4555-5907-FCEF-05FA03E0E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7536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6D631B2-CFF2-EC24-F373-5680CDD79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D8DCDE7-74AD-05E8-C2F2-AD739C888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CBEAAB2-834A-4233-C959-E453FD44B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026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AAC116-3D46-D65A-ECFC-08B8FDC7D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8E5ED2-F33B-A22B-C931-299A77C1EF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AA5CFDF-3AE3-458C-2A83-468FEBFE83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85F93C-2E0A-3447-792C-377AB771A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6F73AE2-D7B5-E22E-5035-78D163E23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11A17C-8AE7-FE6F-F1E4-2207BC524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28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DBB94C-6121-2B3C-FDB7-6F1831A967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146937C-5D87-275C-01FA-A82B6E34F9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622B1DB-4FB7-35E8-B469-F1D1D06C55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927115-9130-2745-3EF8-BC75C3E5E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F115580-F133-7B1B-C94E-FA50A5AA1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D4BEA03-00B0-0FF7-A431-453B64C7B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479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D50D62C-2955-5A60-A239-F6516A045E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29AF36F-B26A-15EC-F078-CBF937C3E5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C90C58-D30B-E3A2-52C3-4FB240822E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6EDC2C-8E10-CD4F-B854-28173D66C7F4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4D44EF-18FF-7703-0CC0-73BA6D2483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06DEBC-E9D9-4733-105F-8CC00CDBBA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D0CB3B-5E0B-B945-B3C8-77F7F0C17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551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5D2B63E3-5599-2409-D7EF-FD600F91CC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6200" y="1056600"/>
            <a:ext cx="4744800" cy="4744800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3E1EBA8E-9C38-E3E4-A5C0-9EF19762C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19287" y="2978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Figure S2.</a:t>
            </a:r>
            <a:endParaRPr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8" name="図 7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DB8E5AEB-3DB8-DB81-F163-9C2DEB6E64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057113"/>
            <a:ext cx="4744800" cy="4744800"/>
          </a:xfrm>
          <a:prstGeom prst="rect">
            <a:avLst/>
          </a:prstGeom>
        </p:spPr>
      </p:pic>
      <p:graphicFrame>
        <p:nvGraphicFramePr>
          <p:cNvPr id="4" name="表 2">
            <a:extLst>
              <a:ext uri="{FF2B5EF4-FFF2-40B4-BE49-F238E27FC236}">
                <a16:creationId xmlns:a16="http://schemas.microsoft.com/office/drawing/2014/main" id="{13B38EEA-4074-5DE1-22C4-B84EAACC5925}"/>
              </a:ext>
            </a:extLst>
          </p:cNvPr>
          <p:cNvGraphicFramePr>
            <a:graphicFrameLocks noGrp="1"/>
          </p:cNvGraphicFramePr>
          <p:nvPr/>
        </p:nvGraphicFramePr>
        <p:xfrm>
          <a:off x="8501936" y="1524348"/>
          <a:ext cx="2341808" cy="773040"/>
        </p:xfrm>
        <a:graphic>
          <a:graphicData uri="http://schemas.openxmlformats.org/drawingml/2006/table">
            <a:tbl>
              <a:tblPr firstRow="1" bandRow="1"/>
              <a:tblGrid>
                <a:gridCol w="892737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470853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978218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10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(n = 43)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.9–9.8)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graphicFrame>
        <p:nvGraphicFramePr>
          <p:cNvPr id="6" name="表 2">
            <a:extLst>
              <a:ext uri="{FF2B5EF4-FFF2-40B4-BE49-F238E27FC236}">
                <a16:creationId xmlns:a16="http://schemas.microsoft.com/office/drawing/2014/main" id="{50533799-5A54-22EB-1348-B354750A05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7010964"/>
              </p:ext>
            </p:extLst>
          </p:nvPr>
        </p:nvGraphicFramePr>
        <p:xfrm>
          <a:off x="3496769" y="1504908"/>
          <a:ext cx="2361248" cy="792480"/>
        </p:xfrm>
        <a:graphic>
          <a:graphicData uri="http://schemas.openxmlformats.org/drawingml/2006/table">
            <a:tbl>
              <a:tblPr firstRow="1" bandRow="1"/>
              <a:tblGrid>
                <a:gridCol w="912177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470853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978218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10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(n = 43)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kumimoji="1" lang="ja-JP" altLang="en-US" sz="1000" b="1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</a:t>
                      </a:r>
                    </a:p>
                    <a:p>
                      <a:pPr algn="ctr"/>
                      <a:r>
                        <a:rPr kumimoji="1" lang="en-US" altLang="ja-JP" sz="10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1–6.0)</a:t>
                      </a:r>
                      <a:endParaRPr kumimoji="1" lang="ja-JP" altLang="en-US" sz="1000" b="1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69A3C2D-F10D-B536-87B7-65BC009818FC}"/>
              </a:ext>
            </a:extLst>
          </p:cNvPr>
          <p:cNvSpPr txBox="1"/>
          <p:nvPr/>
        </p:nvSpPr>
        <p:spPr>
          <a:xfrm>
            <a:off x="1346200" y="105711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4176005-A4A5-E36A-B9CE-71B35050DDFA}"/>
              </a:ext>
            </a:extLst>
          </p:cNvPr>
          <p:cNvSpPr txBox="1"/>
          <p:nvPr/>
        </p:nvSpPr>
        <p:spPr>
          <a:xfrm>
            <a:off x="6110054" y="105711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6CEFBBD-C01B-E917-4E38-52635796574E}"/>
              </a:ext>
            </a:extLst>
          </p:cNvPr>
          <p:cNvSpPr txBox="1"/>
          <p:nvPr/>
        </p:nvSpPr>
        <p:spPr>
          <a:xfrm rot="16200000">
            <a:off x="168049" y="3036824"/>
            <a:ext cx="249299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2531D2B-F3D6-85E2-EE77-332C2AB633E9}"/>
              </a:ext>
            </a:extLst>
          </p:cNvPr>
          <p:cNvSpPr txBox="1"/>
          <p:nvPr/>
        </p:nvSpPr>
        <p:spPr>
          <a:xfrm rot="16200000">
            <a:off x="5361988" y="3041545"/>
            <a:ext cx="173797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A9944F8-5D58-948E-7C10-53F56FAEC856}"/>
              </a:ext>
            </a:extLst>
          </p:cNvPr>
          <p:cNvSpPr txBox="1"/>
          <p:nvPr/>
        </p:nvSpPr>
        <p:spPr>
          <a:xfrm>
            <a:off x="3554125" y="5225930"/>
            <a:ext cx="636393" cy="21544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onths 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16190EB-8F9A-A2AC-EB78-7B94B79100A9}"/>
              </a:ext>
            </a:extLst>
          </p:cNvPr>
          <p:cNvSpPr txBox="1"/>
          <p:nvPr/>
        </p:nvSpPr>
        <p:spPr>
          <a:xfrm>
            <a:off x="8225355" y="5225930"/>
            <a:ext cx="586699" cy="21544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6847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Macintosh PowerPoint</Application>
  <PresentationFormat>ワイド画面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Figure S2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ichiro Yoshino</dc:creator>
  <cp:lastModifiedBy>Koichiro Yoshino</cp:lastModifiedBy>
  <cp:revision>3</cp:revision>
  <dcterms:created xsi:type="dcterms:W3CDTF">2026-01-20T00:24:49Z</dcterms:created>
  <dcterms:modified xsi:type="dcterms:W3CDTF">2026-02-24T02:33:11Z</dcterms:modified>
</cp:coreProperties>
</file>